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1827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8717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5501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53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218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582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17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440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23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4758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78056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3/10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3094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表&#10;&#10;描述已自动生成">
            <a:extLst>
              <a:ext uri="{FF2B5EF4-FFF2-40B4-BE49-F238E27FC236}">
                <a16:creationId xmlns:a16="http://schemas.microsoft.com/office/drawing/2014/main" id="{F718ABC1-27C2-5EB8-E413-36A56197356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356" y="1194186"/>
            <a:ext cx="11191287" cy="5122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00566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内容占位符 4" descr="图表&#10;&#10;中度可信度描述已自动生成">
            <a:extLst>
              <a:ext uri="{FF2B5EF4-FFF2-40B4-BE49-F238E27FC236}">
                <a16:creationId xmlns:a16="http://schemas.microsoft.com/office/drawing/2014/main" id="{33B0C23D-619B-19A7-B7F9-26BB38FF128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678" y="1184989"/>
            <a:ext cx="11654644" cy="5225142"/>
          </a:xfrm>
        </p:spPr>
      </p:pic>
    </p:spTree>
    <p:extLst>
      <p:ext uri="{BB962C8B-B14F-4D97-AF65-F5344CB8AC3E}">
        <p14:creationId xmlns:p14="http://schemas.microsoft.com/office/powerpoint/2010/main" val="4830684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文本&#10;&#10;描述已自动生成">
            <a:extLst>
              <a:ext uri="{FF2B5EF4-FFF2-40B4-BE49-F238E27FC236}">
                <a16:creationId xmlns:a16="http://schemas.microsoft.com/office/drawing/2014/main" id="{C75EB0C4-7B82-921F-BC2B-1E6FA3B3FF2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5721" y="1321898"/>
            <a:ext cx="9460558" cy="47056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557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1274565-44DE-9BBE-A974-AC2D61EA78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2804792"/>
              </p:ext>
            </p:extLst>
          </p:nvPr>
        </p:nvGraphicFramePr>
        <p:xfrm>
          <a:off x="3179353" y="1144494"/>
          <a:ext cx="5833294" cy="435133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37325">
                  <a:extLst>
                    <a:ext uri="{9D8B030D-6E8A-4147-A177-3AD203B41FA5}">
                      <a16:colId xmlns:a16="http://schemas.microsoft.com/office/drawing/2014/main" val="1785807876"/>
                    </a:ext>
                  </a:extLst>
                </a:gridCol>
                <a:gridCol w="2328006">
                  <a:extLst>
                    <a:ext uri="{9D8B030D-6E8A-4147-A177-3AD203B41FA5}">
                      <a16:colId xmlns:a16="http://schemas.microsoft.com/office/drawing/2014/main" val="3731577012"/>
                    </a:ext>
                  </a:extLst>
                </a:gridCol>
                <a:gridCol w="2867963">
                  <a:extLst>
                    <a:ext uri="{9D8B030D-6E8A-4147-A177-3AD203B41FA5}">
                      <a16:colId xmlns:a16="http://schemas.microsoft.com/office/drawing/2014/main" val="2868044766"/>
                    </a:ext>
                  </a:extLst>
                </a:gridCol>
              </a:tblGrid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VEGF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TTGCCTTGCTGCTCTA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TGGTGATGTTGAACTCCT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702164666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TSPAN9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CTCTGCTGCTTGAAGT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GACAATGGTGCCTATG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317324639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LIF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GAACCAGATCAGGAACC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GTCTTCTCCGTGCTGTT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345225781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IL6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GTCTACCACTCACCTCT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GCTGTCTTCACACTTGT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645115191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DLA-64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CCCACTCCCTGAGGTT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TGTTGAACCGCAGGAA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3111722540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EPAS1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GAGAGGAGGAAGGAGAAG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GGTACAAGTTGTCCATCT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336198677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C1R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ATCTCCTGGTGCCGAT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ATAGTCATACAAACAGCCTT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779134323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CCL2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CTGCCTGCTGCTCATA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TGCTGCTGGTGACTCT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556573416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STEAP4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AGAGATCTTCAGCTATTCA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ACACCTCAGTTAGTTCCT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202820309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LMO7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GAATACCTGTCACCTTAC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TCTGTTACTGCCTCCA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778094112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EFEMP1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TCCTAACTATGCTGACTCT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CCTCCGTAGTGGTTGA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3736742664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HMOX1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AGAGAATGCCGAGTTCA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GTTGTGCTCGATCTCC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3403734614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LSP1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GATGAGCAGCACCAGA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TTCACACTGTTACTCTTCC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451536668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DAB2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ACGAGCACAACTAATGG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GTCATCAATGCCAATTAGC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1558854646"/>
                  </a:ext>
                </a:extLst>
              </a:tr>
              <a:tr h="4053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ADAMTSL3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GCCGAGCAGTTAAATGG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GGAGTGGCTTCCAGGA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956573536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OGN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AACAAGCACTGAGAAGAC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AGTCACACCACTCCACA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865206406"/>
                  </a:ext>
                </a:extLst>
              </a:tr>
              <a:tr h="22128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KRT89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GTGCTGAAGAAGGACATAG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TTGCGAGTGAAGAAGGTAG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051310700"/>
                  </a:ext>
                </a:extLst>
              </a:tr>
              <a:tr h="4053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300" u="none" strike="noStrike">
                          <a:effectLst/>
                        </a:rPr>
                        <a:t>RASL11A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>
                          <a:effectLst/>
                        </a:rPr>
                        <a:t>CAAGAGATTCATTGGCGATT</a:t>
                      </a:r>
                      <a:endParaRPr lang="en-US" sz="13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300" u="none" strike="noStrike" dirty="0">
                          <a:effectLst/>
                        </a:rPr>
                        <a:t>GTCATAGTCTGTGATGGAGTA</a:t>
                      </a:r>
                      <a:endParaRPr lang="en-US" sz="13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8851" marR="8851" marT="8851" marB="0" anchor="b"/>
                </a:tc>
                <a:extLst>
                  <a:ext uri="{0D108BD9-81ED-4DB2-BD59-A6C34878D82A}">
                    <a16:rowId xmlns:a16="http://schemas.microsoft.com/office/drawing/2014/main" val="22586606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60672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781BCB8C-CFDC-182F-DFCB-A7FE9FDCB23B}"/>
              </a:ext>
            </a:extLst>
          </p:cNvPr>
          <p:cNvGraphicFramePr>
            <a:graphicFrameLocks noGrp="1"/>
          </p:cNvGraphicFramePr>
          <p:nvPr/>
        </p:nvGraphicFramePr>
        <p:xfrm>
          <a:off x="3601525" y="1748830"/>
          <a:ext cx="4988949" cy="435133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45075">
                  <a:extLst>
                    <a:ext uri="{9D8B030D-6E8A-4147-A177-3AD203B41FA5}">
                      <a16:colId xmlns:a16="http://schemas.microsoft.com/office/drawing/2014/main" val="3319415233"/>
                    </a:ext>
                  </a:extLst>
                </a:gridCol>
                <a:gridCol w="1991037">
                  <a:extLst>
                    <a:ext uri="{9D8B030D-6E8A-4147-A177-3AD203B41FA5}">
                      <a16:colId xmlns:a16="http://schemas.microsoft.com/office/drawing/2014/main" val="3327117941"/>
                    </a:ext>
                  </a:extLst>
                </a:gridCol>
                <a:gridCol w="2452837">
                  <a:extLst>
                    <a:ext uri="{9D8B030D-6E8A-4147-A177-3AD203B41FA5}">
                      <a16:colId xmlns:a16="http://schemas.microsoft.com/office/drawing/2014/main" val="731492572"/>
                    </a:ext>
                  </a:extLst>
                </a:gridCol>
              </a:tblGrid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VW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CCTCTCCGTGTA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GTTGCCATTGCCAT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773814938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S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CAGGTGTCAGTTCT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ACAGCATTGCCA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3198063434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BC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GCTTCCTCTACTTCT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CATCGTCTTCCTCTT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057911764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5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GCAGGAAGAAGAAGAATA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AGAAGTCGGAGGCAG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1698020295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DGRL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CAGATAAGTATAGGAGT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GAATAGGTTACAGCAGAG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1194633424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IGFBP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CTACAAGGTGGACT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GCACTGCTTCTTCT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1958996997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4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AGCCAGACCATTC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TTCTTCTCATACAGACT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97953206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SA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TGACCTTGGAAGTG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TGGCATCCTCCTTG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564421519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6A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GAAGGATAGGAAGCATA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AACTGAACGACACCA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737490989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RRC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GCAGTGTAAGCAGTG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CTCTCGTTCTACTT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3143752190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RRC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TACCTCTACTACTGGCTA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CGTCATCTTCCGTAT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1201287984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IF2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AACCTGGAGTGATA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CTAAGTAGGACATAGTGA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741132070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K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GTCAGTTCATGGATTC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CAGTGTTACTACCTC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3423887081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DEPDC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ACCAAGAGGAGTTATGTAA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CCAGTCAACACAGA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808682808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DLGAP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CAGTTACAGCACAGGA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AAGATGGCGTTCAG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2660987893"/>
                  </a:ext>
                </a:extLst>
              </a:tr>
              <a:tr h="3467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PLEKHA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GCTGCCTCTTCTAC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TCTCGTGGTTGTG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1616740033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SP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GGAGGATGAGACAAGA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AACAAGGACAGCAGA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3921107507"/>
                  </a:ext>
                </a:extLst>
              </a:tr>
              <a:tr h="18925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NL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CAACACCTGACTAT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CTGTATGCTATTGTCCTCTAT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570" marR="7570" marT="7570" marB="0" anchor="b"/>
                </a:tc>
                <a:extLst>
                  <a:ext uri="{0D108BD9-81ED-4DB2-BD59-A6C34878D82A}">
                    <a16:rowId xmlns:a16="http://schemas.microsoft.com/office/drawing/2014/main" val="8079660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976031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720146E-5B0B-603B-BB81-B34625112A67}"/>
              </a:ext>
            </a:extLst>
          </p:cNvPr>
          <p:cNvGraphicFramePr>
            <a:graphicFrameLocks noGrp="1"/>
          </p:cNvGraphicFramePr>
          <p:nvPr/>
        </p:nvGraphicFramePr>
        <p:xfrm>
          <a:off x="3546526" y="1825626"/>
          <a:ext cx="5098947" cy="435133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57093">
                  <a:extLst>
                    <a:ext uri="{9D8B030D-6E8A-4147-A177-3AD203B41FA5}">
                      <a16:colId xmlns:a16="http://schemas.microsoft.com/office/drawing/2014/main" val="2547713567"/>
                    </a:ext>
                  </a:extLst>
                </a:gridCol>
                <a:gridCol w="2034936">
                  <a:extLst>
                    <a:ext uri="{9D8B030D-6E8A-4147-A177-3AD203B41FA5}">
                      <a16:colId xmlns:a16="http://schemas.microsoft.com/office/drawing/2014/main" val="3461755430"/>
                    </a:ext>
                  </a:extLst>
                </a:gridCol>
                <a:gridCol w="2506918">
                  <a:extLst>
                    <a:ext uri="{9D8B030D-6E8A-4147-A177-3AD203B41FA5}">
                      <a16:colId xmlns:a16="http://schemas.microsoft.com/office/drawing/2014/main" val="2504519550"/>
                    </a:ext>
                  </a:extLst>
                </a:gridCol>
              </a:tblGrid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SM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CTCAGGTGTCAGTTCT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ACAGCATTGCCA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990037723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VWF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CCTCTCCGTGTA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AGTTGCCATTGCCAT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801674283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BCG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GCTTCCTCTTCTTC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GGTCTTGGCTAGGTAG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784901233"/>
                  </a:ext>
                </a:extLst>
              </a:tr>
              <a:tr h="3543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APTM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ATCACTGTCCTCATCC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TCGGTAGCATCTTG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803293078"/>
                  </a:ext>
                </a:extLst>
              </a:tr>
              <a:tr h="3543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DGRL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ACAGATAAGTATAGGAGTC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GAATAGGTTACAGCAGAG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507040820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EMC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CCTTCAAGTGACCAT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TTCCACCTATCAATTC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180111347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4A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AGCCAGACCATTC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TTCTTCTCATACAGACTT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247506967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OL6A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AGGTGAGGTGGAGA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ACGAAGGATGGTAACA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66814597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SVEP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ACCTGCCATCTTGTTG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CCATTCCACTTGCCA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658382260"/>
                  </a:ext>
                </a:extLst>
              </a:tr>
              <a:tr h="3543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FSD2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TCAGCACAGAGCAG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GGAAGCCAGCAATAAG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586909085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CL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TGCCTGCTGCTCAT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TGCTGCTGGTGACTC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3744826746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IP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AACCTTCGCACCTCTG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GGCAACACTGTATC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04652747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MP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GTTGATTCTGCCATTG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GTATCGCTTGTCCATTGTT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869516698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PI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CTGGCAGTGTTCCT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GGATCTCGACCTCTA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66020286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TK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TCATCGCCAAGACC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CAGCAATGTAGCACTCA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3805366389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LMP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CTTACTCCAGCCGTC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TCTCCTTCCAACTCACA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196212512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MM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ATCTTGTAAGCAGCCTCAG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TCATCCTTGTCCACT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295509935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IF1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ACCTGTCTCTTCGCTTA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ATTCGGCTCGTTATTCTG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b"/>
                </a:tc>
                <a:extLst>
                  <a:ext uri="{0D108BD9-81ED-4DB2-BD59-A6C34878D82A}">
                    <a16:rowId xmlns:a16="http://schemas.microsoft.com/office/drawing/2014/main" val="1724262861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extLst>
                  <a:ext uri="{0D108BD9-81ED-4DB2-BD59-A6C34878D82A}">
                    <a16:rowId xmlns:a16="http://schemas.microsoft.com/office/drawing/2014/main" val="481683273"/>
                  </a:ext>
                </a:extLst>
              </a:tr>
              <a:tr h="19342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Gapdh</a:t>
                      </a:r>
                      <a:endParaRPr lang="en-US" sz="1100" b="0" i="0" u="none" strike="noStrike">
                        <a:solidFill>
                          <a:srgbClr val="121212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>
                          <a:effectLst/>
                        </a:rPr>
                        <a:t>GTGAAGGTCGGAGTGAA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u="none" strike="noStrike" dirty="0">
                          <a:effectLst/>
                        </a:rPr>
                        <a:t>GCAGAAGGAGCAGAGATG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</a:endParaRPr>
                    </a:p>
                  </a:txBody>
                  <a:tcPr marL="7737" marR="7737" marT="7737" marB="0" anchor="ctr"/>
                </a:tc>
                <a:extLst>
                  <a:ext uri="{0D108BD9-81ED-4DB2-BD59-A6C34878D82A}">
                    <a16:rowId xmlns:a16="http://schemas.microsoft.com/office/drawing/2014/main" val="13318168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8421237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4874CB"/>
      </a:accent1>
      <a:accent2>
        <a:srgbClr val="E6724B"/>
      </a:accent2>
      <a:accent3>
        <a:srgbClr val="EFBB1F"/>
      </a:accent3>
      <a:accent4>
        <a:srgbClr val="75BD42"/>
      </a:accent4>
      <a:accent5>
        <a:srgbClr val="30C0B4"/>
      </a:accent5>
      <a:accent6>
        <a:srgbClr val="E05269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WPS" id="{8741FFC2-4D7D-48D1-88A6-21A4E405BEEE}" vid="{BE4B9CD3-767A-4D54-8AE3-5DB2A8AFC4DC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5</Words>
  <Application>Microsoft Office PowerPoint</Application>
  <PresentationFormat>宽屏</PresentationFormat>
  <Paragraphs>165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</dc:creator>
  <cp:lastModifiedBy>pengxiu dai</cp:lastModifiedBy>
  <cp:revision>2</cp:revision>
  <dcterms:created xsi:type="dcterms:W3CDTF">2023-10-25T11:52:55Z</dcterms:created>
  <dcterms:modified xsi:type="dcterms:W3CDTF">2023-10-25T11:56:03Z</dcterms:modified>
</cp:coreProperties>
</file>